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10058400" cy="5741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0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8B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311" autoAdjust="0"/>
    <p:restoredTop sz="84935" autoAdjust="0"/>
  </p:normalViewPr>
  <p:slideViewPr>
    <p:cSldViewPr snapToGrid="0">
      <p:cViewPr varScale="1">
        <p:scale>
          <a:sx n="122" d="100"/>
          <a:sy n="122" d="100"/>
        </p:scale>
        <p:origin x="1256" y="184"/>
      </p:cViewPr>
      <p:guideLst>
        <p:guide orient="horz" pos="1808"/>
        <p:guide pos="31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NULL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TH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Lit>
              <c:formatCode>0.00</c:formatCode>
              <c:ptCount val="118"/>
              <c:pt idx="0">
                <c:v>67.693711951781054</c:v>
              </c:pt>
              <c:pt idx="1">
                <c:v>81.156626352697444</c:v>
              </c:pt>
              <c:pt idx="2">
                <c:v>50.604110381165832</c:v>
              </c:pt>
              <c:pt idx="3">
                <c:v>46.51770735841054</c:v>
              </c:pt>
              <c:pt idx="4">
                <c:v>41.778221429060771</c:v>
              </c:pt>
              <c:pt idx="5">
                <c:v>50.363180253494832</c:v>
              </c:pt>
              <c:pt idx="6">
                <c:v>84.672641679999018</c:v>
              </c:pt>
              <c:pt idx="7">
                <c:v>85.022741530377004</c:v>
              </c:pt>
              <c:pt idx="8">
                <c:v>93.529629297718415</c:v>
              </c:pt>
              <c:pt idx="9">
                <c:v>83.440447353950546</c:v>
              </c:pt>
              <c:pt idx="10">
                <c:v>69.847364707490826</c:v>
              </c:pt>
              <c:pt idx="11">
                <c:v>72.413096477959314</c:v>
              </c:pt>
              <c:pt idx="12">
                <c:v>59.766659542394883</c:v>
              </c:pt>
              <c:pt idx="13">
                <c:v>93.646757168333323</c:v>
              </c:pt>
              <c:pt idx="14">
                <c:v>89.478547824131638</c:v>
              </c:pt>
              <c:pt idx="15">
                <c:v>65.572574633600013</c:v>
              </c:pt>
              <c:pt idx="16">
                <c:v>66.398554792270417</c:v>
              </c:pt>
              <c:pt idx="17">
                <c:v>66.6992092371936</c:v>
              </c:pt>
              <c:pt idx="18">
                <c:v>67.221516709437878</c:v>
              </c:pt>
              <c:pt idx="19">
                <c:v>90.506363974322312</c:v>
              </c:pt>
              <c:pt idx="20">
                <c:v>49.712483929499079</c:v>
              </c:pt>
              <c:pt idx="21">
                <c:v>78.806754924710049</c:v>
              </c:pt>
              <c:pt idx="22">
                <c:v>66.638246708190607</c:v>
              </c:pt>
              <c:pt idx="23">
                <c:v>47.551311260561071</c:v>
              </c:pt>
              <c:pt idx="24">
                <c:v>91.280578377861971</c:v>
              </c:pt>
              <c:pt idx="25">
                <c:v>91.76733566477553</c:v>
              </c:pt>
              <c:pt idx="26">
                <c:v>44.917091365716793</c:v>
              </c:pt>
              <c:pt idx="27">
                <c:v>97.020310777153355</c:v>
              </c:pt>
              <c:pt idx="28">
                <c:v>80.562672944013485</c:v>
              </c:pt>
              <c:pt idx="29">
                <c:v>83.754548407670612</c:v>
              </c:pt>
              <c:pt idx="30">
                <c:v>67.697056641964849</c:v>
              </c:pt>
              <c:pt idx="31">
                <c:v>77.73260980366824</c:v>
              </c:pt>
              <c:pt idx="32">
                <c:v>48.803417080231689</c:v>
              </c:pt>
              <c:pt idx="33">
                <c:v>73.46045552178667</c:v>
              </c:pt>
              <c:pt idx="34">
                <c:v>72.558831853628732</c:v>
              </c:pt>
              <c:pt idx="35">
                <c:v>65.062535630461738</c:v>
              </c:pt>
              <c:pt idx="36">
                <c:v>79.687795006994904</c:v>
              </c:pt>
              <c:pt idx="37">
                <c:v>63.695157011540253</c:v>
              </c:pt>
              <c:pt idx="38">
                <c:v>77.390402690913916</c:v>
              </c:pt>
              <c:pt idx="39">
                <c:v>54.830741742866813</c:v>
              </c:pt>
              <c:pt idx="40">
                <c:v>78.647688748764139</c:v>
              </c:pt>
              <c:pt idx="41">
                <c:v>52.82756565400372</c:v>
              </c:pt>
              <c:pt idx="42">
                <c:v>54.475408242780311</c:v>
              </c:pt>
              <c:pt idx="43">
                <c:v>62.788409099187049</c:v>
              </c:pt>
              <c:pt idx="44">
                <c:v>36.204581467831318</c:v>
              </c:pt>
              <c:pt idx="45">
                <c:v>56.207315384192199</c:v>
              </c:pt>
              <c:pt idx="46">
                <c:v>70.414782849689487</c:v>
              </c:pt>
              <c:pt idx="47">
                <c:v>74.159130968863295</c:v>
              </c:pt>
              <c:pt idx="48">
                <c:v>41.101489385474203</c:v>
              </c:pt>
              <c:pt idx="49">
                <c:v>86.651228069938966</c:v>
              </c:pt>
              <c:pt idx="50">
                <c:v>64.877570622215814</c:v>
              </c:pt>
              <c:pt idx="51">
                <c:v>55.962346399714633</c:v>
              </c:pt>
              <c:pt idx="52">
                <c:v>67.228211591596732</c:v>
              </c:pt>
              <c:pt idx="53">
                <c:v>80.83879729035614</c:v>
              </c:pt>
              <c:pt idx="54">
                <c:v>28.297891469061881</c:v>
              </c:pt>
              <c:pt idx="55">
                <c:v>56.563615764354367</c:v>
              </c:pt>
              <c:pt idx="56">
                <c:v>68.154709761256854</c:v>
              </c:pt>
              <c:pt idx="57">
                <c:v>46.277211325228379</c:v>
              </c:pt>
              <c:pt idx="58">
                <c:v>79.05881990400087</c:v>
              </c:pt>
              <c:pt idx="59">
                <c:v>61.36863664613896</c:v>
              </c:pt>
              <c:pt idx="60">
                <c:v>66.694231770988992</c:v>
              </c:pt>
              <c:pt idx="61">
                <c:v>50.047273361447829</c:v>
              </c:pt>
              <c:pt idx="62">
                <c:v>70.393888153157945</c:v>
              </c:pt>
              <c:pt idx="63">
                <c:v>59.16699457327946</c:v>
              </c:pt>
              <c:pt idx="64">
                <c:v>44.777261421173677</c:v>
              </c:pt>
              <c:pt idx="65">
                <c:v>88.199491466995411</c:v>
              </c:pt>
              <c:pt idx="66">
                <c:v>45.59562609459158</c:v>
              </c:pt>
              <c:pt idx="67">
                <c:v>63.914162599278917</c:v>
              </c:pt>
              <c:pt idx="68">
                <c:v>53.323127441905932</c:v>
              </c:pt>
              <c:pt idx="69">
                <c:v>42.996738814385473</c:v>
              </c:pt>
              <c:pt idx="70">
                <c:v>38.203167846353097</c:v>
              </c:pt>
              <c:pt idx="71">
                <c:v>64.236400589808696</c:v>
              </c:pt>
              <c:pt idx="72">
                <c:v>36.483986605166002</c:v>
              </c:pt>
              <c:pt idx="73">
                <c:v>40.211544400806631</c:v>
              </c:pt>
              <c:pt idx="74">
                <c:v>44.327180204103797</c:v>
              </c:pt>
              <c:pt idx="75">
                <c:v>57.092289048917443</c:v>
              </c:pt>
              <c:pt idx="76">
                <c:v>62.880232736599837</c:v>
              </c:pt>
              <c:pt idx="77">
                <c:v>24.355541725752701</c:v>
              </c:pt>
              <c:pt idx="78">
                <c:v>74.511153897843897</c:v>
              </c:pt>
              <c:pt idx="79">
                <c:v>71.214296602793198</c:v>
              </c:pt>
              <c:pt idx="80">
                <c:v>74.729312477684715</c:v>
              </c:pt>
              <c:pt idx="81">
                <c:v>73.698088243896549</c:v>
              </c:pt>
              <c:pt idx="82">
                <c:v>74.855710658063188</c:v>
              </c:pt>
              <c:pt idx="83">
                <c:v>67.299589081821964</c:v>
              </c:pt>
              <c:pt idx="84">
                <c:v>62.218853912804413</c:v>
              </c:pt>
              <c:pt idx="85">
                <c:v>63.552054508276733</c:v>
              </c:pt>
              <c:pt idx="86">
                <c:v>69.241442003312983</c:v>
              </c:pt>
              <c:pt idx="87">
                <c:v>63.235708410306579</c:v>
              </c:pt>
              <c:pt idx="88">
                <c:v>66.977376330208102</c:v>
              </c:pt>
              <c:pt idx="89">
                <c:v>57.619805175197783</c:v>
              </c:pt>
              <c:pt idx="90">
                <c:v>76.416500693377543</c:v>
              </c:pt>
              <c:pt idx="91">
                <c:v>64.689638131682926</c:v>
              </c:pt>
              <c:pt idx="92">
                <c:v>53.810653228831178</c:v>
              </c:pt>
              <c:pt idx="93">
                <c:v>80.7666999526014</c:v>
              </c:pt>
              <c:pt idx="94">
                <c:v>51.756273709486457</c:v>
              </c:pt>
              <c:pt idx="95">
                <c:v>66.530864737380995</c:v>
              </c:pt>
              <c:pt idx="96">
                <c:v>64.514327110014577</c:v>
              </c:pt>
              <c:pt idx="97">
                <c:v>74.982409393033649</c:v>
              </c:pt>
              <c:pt idx="98">
                <c:v>68.236290188702299</c:v>
              </c:pt>
              <c:pt idx="99">
                <c:v>75.622335663338959</c:v>
              </c:pt>
              <c:pt idx="100">
                <c:v>64.850144284515878</c:v>
              </c:pt>
              <c:pt idx="101">
                <c:v>78.573839632363089</c:v>
              </c:pt>
              <c:pt idx="102">
                <c:v>73.172490126576889</c:v>
              </c:pt>
              <c:pt idx="103">
                <c:v>71.596263488847228</c:v>
              </c:pt>
              <c:pt idx="104">
                <c:v>64.767223655635505</c:v>
              </c:pt>
              <c:pt idx="105">
                <c:v>75.867063075864252</c:v>
              </c:pt>
              <c:pt idx="106">
                <c:v>77.052592859295018</c:v>
              </c:pt>
              <c:pt idx="107">
                <c:v>63.897973180265559</c:v>
              </c:pt>
              <c:pt idx="108">
                <c:v>63.012952152933643</c:v>
              </c:pt>
              <c:pt idx="109">
                <c:v>67.785911096532686</c:v>
              </c:pt>
              <c:pt idx="110">
                <c:v>78.338979952642674</c:v>
              </c:pt>
              <c:pt idx="111">
                <c:v>84.409563913674262</c:v>
              </c:pt>
              <c:pt idx="112">
                <c:v>57.086138109646448</c:v>
              </c:pt>
              <c:pt idx="113">
                <c:v>71.473632622947264</c:v>
              </c:pt>
              <c:pt idx="114">
                <c:v>71.335331389949317</c:v>
              </c:pt>
              <c:pt idx="115">
                <c:v>68.236023029064967</c:v>
              </c:pt>
              <c:pt idx="116">
                <c:v>64.348285482525853</c:v>
              </c:pt>
              <c:pt idx="117">
                <c:v>62.101658336696232</c:v>
              </c:pt>
            </c:numLit>
          </c:xVal>
          <c:yVal>
            <c:numLit>
              <c:formatCode>0.00</c:formatCode>
              <c:ptCount val="118"/>
              <c:pt idx="0">
                <c:v>71.73</c:v>
              </c:pt>
              <c:pt idx="1">
                <c:v>75.38</c:v>
              </c:pt>
              <c:pt idx="2">
                <c:v>53.84</c:v>
              </c:pt>
              <c:pt idx="3">
                <c:v>49.17</c:v>
              </c:pt>
              <c:pt idx="4">
                <c:v>35.229999999999997</c:v>
              </c:pt>
              <c:pt idx="5">
                <c:v>56.21</c:v>
              </c:pt>
              <c:pt idx="6">
                <c:v>87.68</c:v>
              </c:pt>
              <c:pt idx="7">
                <c:v>80.64</c:v>
              </c:pt>
              <c:pt idx="8">
                <c:v>95.89</c:v>
              </c:pt>
              <c:pt idx="9">
                <c:v>93.64</c:v>
              </c:pt>
              <c:pt idx="10">
                <c:v>88.78</c:v>
              </c:pt>
              <c:pt idx="11">
                <c:v>85.7</c:v>
              </c:pt>
              <c:pt idx="12">
                <c:v>57.39</c:v>
              </c:pt>
              <c:pt idx="13">
                <c:v>86.51</c:v>
              </c:pt>
              <c:pt idx="14">
                <c:v>87.59</c:v>
              </c:pt>
              <c:pt idx="15">
                <c:v>70.25</c:v>
              </c:pt>
              <c:pt idx="16">
                <c:v>80.58</c:v>
              </c:pt>
              <c:pt idx="17">
                <c:v>80.75</c:v>
              </c:pt>
              <c:pt idx="18">
                <c:v>57.81</c:v>
              </c:pt>
              <c:pt idx="19">
                <c:v>98.54</c:v>
              </c:pt>
              <c:pt idx="20">
                <c:v>45.4</c:v>
              </c:pt>
              <c:pt idx="21">
                <c:v>83.97</c:v>
              </c:pt>
              <c:pt idx="22">
                <c:v>62.84</c:v>
              </c:pt>
              <c:pt idx="23">
                <c:v>47.53</c:v>
              </c:pt>
              <c:pt idx="24">
                <c:v>100.25</c:v>
              </c:pt>
              <c:pt idx="25">
                <c:v>75.55</c:v>
              </c:pt>
              <c:pt idx="26">
                <c:v>39.5</c:v>
              </c:pt>
              <c:pt idx="27">
                <c:v>102.61</c:v>
              </c:pt>
              <c:pt idx="28">
                <c:v>87.3</c:v>
              </c:pt>
              <c:pt idx="29">
                <c:v>71.17</c:v>
              </c:pt>
              <c:pt idx="30">
                <c:v>54.7</c:v>
              </c:pt>
              <c:pt idx="31">
                <c:v>76.7</c:v>
              </c:pt>
              <c:pt idx="32">
                <c:v>50.46</c:v>
              </c:pt>
              <c:pt idx="33">
                <c:v>68.08</c:v>
              </c:pt>
              <c:pt idx="34">
                <c:v>82.16</c:v>
              </c:pt>
              <c:pt idx="35">
                <c:v>68.14</c:v>
              </c:pt>
              <c:pt idx="36">
                <c:v>75.290000000000006</c:v>
              </c:pt>
              <c:pt idx="37">
                <c:v>58.69</c:v>
              </c:pt>
              <c:pt idx="38">
                <c:v>47.06</c:v>
              </c:pt>
              <c:pt idx="39">
                <c:v>48.55</c:v>
              </c:pt>
              <c:pt idx="40">
                <c:v>72.209999999999994</c:v>
              </c:pt>
              <c:pt idx="41">
                <c:v>47.51</c:v>
              </c:pt>
              <c:pt idx="42">
                <c:v>63.53</c:v>
              </c:pt>
              <c:pt idx="43">
                <c:v>58.97</c:v>
              </c:pt>
              <c:pt idx="44">
                <c:v>63.26</c:v>
              </c:pt>
              <c:pt idx="45">
                <c:v>80.72</c:v>
              </c:pt>
              <c:pt idx="46">
                <c:v>78.650000000000006</c:v>
              </c:pt>
              <c:pt idx="47">
                <c:v>80.959999999999994</c:v>
              </c:pt>
              <c:pt idx="48">
                <c:v>47.33</c:v>
              </c:pt>
              <c:pt idx="49">
                <c:v>93.66</c:v>
              </c:pt>
              <c:pt idx="50">
                <c:v>45.76</c:v>
              </c:pt>
              <c:pt idx="51">
                <c:v>50.94</c:v>
              </c:pt>
              <c:pt idx="52">
                <c:v>71.69</c:v>
              </c:pt>
              <c:pt idx="53">
                <c:v>40.28</c:v>
              </c:pt>
              <c:pt idx="54">
                <c:v>31.48</c:v>
              </c:pt>
              <c:pt idx="55">
                <c:v>45.21</c:v>
              </c:pt>
              <c:pt idx="56">
                <c:v>91.97</c:v>
              </c:pt>
              <c:pt idx="57">
                <c:v>50.71</c:v>
              </c:pt>
              <c:pt idx="58">
                <c:v>82.54</c:v>
              </c:pt>
              <c:pt idx="59">
                <c:v>46.7</c:v>
              </c:pt>
              <c:pt idx="60">
                <c:v>61.76</c:v>
              </c:pt>
              <c:pt idx="61">
                <c:v>59.36</c:v>
              </c:pt>
              <c:pt idx="62">
                <c:v>52.58</c:v>
              </c:pt>
              <c:pt idx="63">
                <c:v>54.54</c:v>
              </c:pt>
              <c:pt idx="64">
                <c:v>43.36</c:v>
              </c:pt>
              <c:pt idx="65">
                <c:v>98.8</c:v>
              </c:pt>
              <c:pt idx="66">
                <c:v>46.04</c:v>
              </c:pt>
              <c:pt idx="67">
                <c:v>56.21</c:v>
              </c:pt>
              <c:pt idx="68">
                <c:v>55.68</c:v>
              </c:pt>
              <c:pt idx="69">
                <c:v>40.270000000000003</c:v>
              </c:pt>
              <c:pt idx="70">
                <c:v>19.7</c:v>
              </c:pt>
              <c:pt idx="71">
                <c:v>70.25</c:v>
              </c:pt>
              <c:pt idx="72">
                <c:v>32.619999999999997</c:v>
              </c:pt>
              <c:pt idx="73">
                <c:v>37</c:v>
              </c:pt>
              <c:pt idx="74">
                <c:v>36.479999999999997</c:v>
              </c:pt>
              <c:pt idx="75">
                <c:v>57.17</c:v>
              </c:pt>
              <c:pt idx="76">
                <c:v>57.52</c:v>
              </c:pt>
              <c:pt idx="77">
                <c:v>18.329999999999998</c:v>
              </c:pt>
              <c:pt idx="78">
                <c:v>88.1</c:v>
              </c:pt>
              <c:pt idx="79">
                <c:v>90.88</c:v>
              </c:pt>
              <c:pt idx="80">
                <c:v>76.58</c:v>
              </c:pt>
              <c:pt idx="81">
                <c:v>71</c:v>
              </c:pt>
              <c:pt idx="82">
                <c:v>86.58</c:v>
              </c:pt>
              <c:pt idx="83">
                <c:v>69.89</c:v>
              </c:pt>
              <c:pt idx="84">
                <c:v>67.89</c:v>
              </c:pt>
              <c:pt idx="85">
                <c:v>51</c:v>
              </c:pt>
              <c:pt idx="86">
                <c:v>63.15</c:v>
              </c:pt>
              <c:pt idx="87">
                <c:v>57.86</c:v>
              </c:pt>
              <c:pt idx="88">
                <c:v>62.24</c:v>
              </c:pt>
              <c:pt idx="89">
                <c:v>49.01</c:v>
              </c:pt>
              <c:pt idx="90">
                <c:v>80.930000000000007</c:v>
              </c:pt>
              <c:pt idx="91">
                <c:v>56.44</c:v>
              </c:pt>
              <c:pt idx="92">
                <c:v>61.21</c:v>
              </c:pt>
              <c:pt idx="93">
                <c:v>95.53</c:v>
              </c:pt>
              <c:pt idx="94">
                <c:v>57.67</c:v>
              </c:pt>
              <c:pt idx="95">
                <c:v>65.06</c:v>
              </c:pt>
              <c:pt idx="96">
                <c:v>80.09</c:v>
              </c:pt>
              <c:pt idx="97">
                <c:v>68.849999999999994</c:v>
              </c:pt>
              <c:pt idx="98">
                <c:v>64.62</c:v>
              </c:pt>
              <c:pt idx="99">
                <c:v>64.489999999999995</c:v>
              </c:pt>
              <c:pt idx="100">
                <c:v>69.599999999999994</c:v>
              </c:pt>
              <c:pt idx="101">
                <c:v>70.819999999999993</c:v>
              </c:pt>
              <c:pt idx="102">
                <c:v>87.46</c:v>
              </c:pt>
              <c:pt idx="103">
                <c:v>83.11</c:v>
              </c:pt>
              <c:pt idx="104">
                <c:v>62.9</c:v>
              </c:pt>
              <c:pt idx="105">
                <c:v>71.459999999999994</c:v>
              </c:pt>
              <c:pt idx="106">
                <c:v>81.5</c:v>
              </c:pt>
              <c:pt idx="107">
                <c:v>74.599999999999994</c:v>
              </c:pt>
              <c:pt idx="108">
                <c:v>65.25</c:v>
              </c:pt>
              <c:pt idx="109">
                <c:v>67.77</c:v>
              </c:pt>
              <c:pt idx="110">
                <c:v>83.39</c:v>
              </c:pt>
              <c:pt idx="111">
                <c:v>79.37</c:v>
              </c:pt>
              <c:pt idx="112">
                <c:v>52.66</c:v>
              </c:pt>
              <c:pt idx="113">
                <c:v>70.38</c:v>
              </c:pt>
              <c:pt idx="114">
                <c:v>57.6</c:v>
              </c:pt>
              <c:pt idx="115">
                <c:v>70.53</c:v>
              </c:pt>
              <c:pt idx="116">
                <c:v>52.56</c:v>
              </c:pt>
              <c:pt idx="117">
                <c:v>57.61</c:v>
              </c:pt>
            </c:numLit>
          </c:yVal>
          <c:smooth val="0"/>
          <c:extLst>
            <c:ext xmlns:c16="http://schemas.microsoft.com/office/drawing/2014/chart" uri="{C3380CC4-5D6E-409C-BE32-E72D297353CC}">
              <c16:uniqueId val="{00000001-1AEB-1F47-B161-90B15C10A7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41954592"/>
        <c:axId val="541954264"/>
      </c:scatterChart>
      <c:valAx>
        <c:axId val="541954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 dirty="0"/>
                  <a:t>VA-</a:t>
                </a:r>
                <a:r>
                  <a:rPr lang="en-US" baseline="0" dirty="0" err="1"/>
                  <a:t>GFRModel</a:t>
                </a:r>
                <a:endParaRPr 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TH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TH"/>
          </a:p>
        </c:txPr>
        <c:crossAx val="541954264"/>
        <c:crosses val="autoZero"/>
        <c:crossBetween val="midCat"/>
      </c:valAx>
      <c:valAx>
        <c:axId val="5419542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aseline="0" dirty="0"/>
                  <a:t>NB-GFR</a:t>
                </a:r>
                <a:endParaRPr lang="en-US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TH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TH"/>
          </a:p>
        </c:txPr>
        <c:crossAx val="541954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tx2">
        <a:lumMod val="10000"/>
      </a:schemeClr>
    </a:solidFill>
    <a:ln>
      <a:noFill/>
    </a:ln>
    <a:effectLst/>
  </c:spPr>
  <c:txPr>
    <a:bodyPr/>
    <a:lstStyle/>
    <a:p>
      <a:pPr>
        <a:defRPr/>
      </a:pPr>
      <a:endParaRPr lang="en-TH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7890ED-11B8-4800-B8B2-72C7F4E99478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25488" y="1143000"/>
            <a:ext cx="5407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7101A8-4275-45CB-8E2F-D2818FB70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768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723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96729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09934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36309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3663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57300" y="939720"/>
            <a:ext cx="7543800" cy="1999062"/>
          </a:xfrm>
        </p:spPr>
        <p:txBody>
          <a:bodyPr anchor="b"/>
          <a:lstStyle>
            <a:lvl1pPr algn="ctr"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3015873"/>
            <a:ext cx="7543800" cy="1386318"/>
          </a:xfrm>
        </p:spPr>
        <p:txBody>
          <a:bodyPr/>
          <a:lstStyle>
            <a:lvl1pPr marL="0" indent="0" algn="ctr">
              <a:buNone/>
              <a:defRPr sz="1980"/>
            </a:lvl1pPr>
            <a:lvl2pPr marL="377190" indent="0" algn="ctr">
              <a:buNone/>
              <a:defRPr sz="1650"/>
            </a:lvl2pPr>
            <a:lvl3pPr marL="754380" indent="0" algn="ctr">
              <a:buNone/>
              <a:defRPr sz="1485"/>
            </a:lvl3pPr>
            <a:lvl4pPr marL="1131570" indent="0" algn="ctr">
              <a:buNone/>
              <a:defRPr sz="1320"/>
            </a:lvl4pPr>
            <a:lvl5pPr marL="1508760" indent="0" algn="ctr">
              <a:buNone/>
              <a:defRPr sz="1320"/>
            </a:lvl5pPr>
            <a:lvl6pPr marL="1885950" indent="0" algn="ctr">
              <a:buNone/>
              <a:defRPr sz="1320"/>
            </a:lvl6pPr>
            <a:lvl7pPr marL="2263140" indent="0" algn="ctr">
              <a:buNone/>
              <a:defRPr sz="1320"/>
            </a:lvl7pPr>
            <a:lvl8pPr marL="2640330" indent="0" algn="ctr">
              <a:buNone/>
              <a:defRPr sz="1320"/>
            </a:lvl8pPr>
            <a:lvl9pPr marL="3017520" indent="0" algn="ctr">
              <a:buNone/>
              <a:defRPr sz="13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213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447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2" y="305708"/>
            <a:ext cx="2168843" cy="48660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305708"/>
            <a:ext cx="6380798" cy="486606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8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955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6" y="1431510"/>
            <a:ext cx="8675370" cy="2388507"/>
          </a:xfrm>
        </p:spPr>
        <p:txBody>
          <a:bodyPr anchor="b"/>
          <a:lstStyle>
            <a:lvl1pPr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6" y="3842614"/>
            <a:ext cx="8675370" cy="1256059"/>
          </a:xfrm>
        </p:spPr>
        <p:txBody>
          <a:bodyPr/>
          <a:lstStyle>
            <a:lvl1pPr marL="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1pPr>
            <a:lvl2pPr marL="377190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2pPr>
            <a:lvl3pPr marL="754380" indent="0">
              <a:buNone/>
              <a:defRPr sz="1485">
                <a:solidFill>
                  <a:schemeClr val="tx1">
                    <a:tint val="75000"/>
                  </a:schemeClr>
                </a:solidFill>
              </a:defRPr>
            </a:lvl3pPr>
            <a:lvl4pPr marL="113157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4pPr>
            <a:lvl5pPr marL="150876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5pPr>
            <a:lvl6pPr marL="188595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6pPr>
            <a:lvl7pPr marL="226314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7pPr>
            <a:lvl8pPr marL="26403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8pPr>
            <a:lvl9pPr marL="301752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861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83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05708"/>
            <a:ext cx="8675370" cy="11098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407585"/>
            <a:ext cx="4255174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097421"/>
            <a:ext cx="4255174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5" y="1407585"/>
            <a:ext cx="4276130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5" y="2097421"/>
            <a:ext cx="4276130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073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70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054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826740"/>
            <a:ext cx="5092065" cy="4080533"/>
          </a:xfrm>
        </p:spPr>
        <p:txBody>
          <a:bodyPr/>
          <a:lstStyle>
            <a:lvl1pPr>
              <a:defRPr sz="2640"/>
            </a:lvl1pPr>
            <a:lvl2pPr>
              <a:defRPr sz="2310"/>
            </a:lvl2pPr>
            <a:lvl3pPr>
              <a:defRPr sz="1980"/>
            </a:lvl3pPr>
            <a:lvl4pPr>
              <a:defRPr sz="1650"/>
            </a:lvl4pPr>
            <a:lvl5pPr>
              <a:defRPr sz="1650"/>
            </a:lvl5pPr>
            <a:lvl6pPr>
              <a:defRPr sz="1650"/>
            </a:lvl6pPr>
            <a:lvl7pPr>
              <a:defRPr sz="1650"/>
            </a:lvl7pPr>
            <a:lvl8pPr>
              <a:defRPr sz="1650"/>
            </a:lvl8pPr>
            <a:lvl9pPr>
              <a:defRPr sz="165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86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826740"/>
            <a:ext cx="5092065" cy="4080533"/>
          </a:xfrm>
        </p:spPr>
        <p:txBody>
          <a:bodyPr anchor="t"/>
          <a:lstStyle>
            <a:lvl1pPr marL="0" indent="0">
              <a:buNone/>
              <a:defRPr sz="2640"/>
            </a:lvl1pPr>
            <a:lvl2pPr marL="377190" indent="0">
              <a:buNone/>
              <a:defRPr sz="2310"/>
            </a:lvl2pPr>
            <a:lvl3pPr marL="754380" indent="0">
              <a:buNone/>
              <a:defRPr sz="1980"/>
            </a:lvl3pPr>
            <a:lvl4pPr marL="1131570" indent="0">
              <a:buNone/>
              <a:defRPr sz="1650"/>
            </a:lvl4pPr>
            <a:lvl5pPr marL="1508760" indent="0">
              <a:buNone/>
              <a:defRPr sz="1650"/>
            </a:lvl5pPr>
            <a:lvl6pPr marL="1885950" indent="0">
              <a:buNone/>
              <a:defRPr sz="1650"/>
            </a:lvl6pPr>
            <a:lvl7pPr marL="2263140" indent="0">
              <a:buNone/>
              <a:defRPr sz="1650"/>
            </a:lvl7pPr>
            <a:lvl8pPr marL="2640330" indent="0">
              <a:buNone/>
              <a:defRPr sz="1650"/>
            </a:lvl8pPr>
            <a:lvl9pPr marL="3017520" indent="0">
              <a:buNone/>
              <a:defRPr sz="16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44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305708"/>
            <a:ext cx="8675370" cy="11098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1528538"/>
            <a:ext cx="8675370" cy="36432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559BE-96A6-4C40-8576-E268AFCD6E85}" type="datetimeFigureOut">
              <a:rPr lang="en-US" smtClean="0"/>
              <a:t>10/3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5321972"/>
            <a:ext cx="339471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86104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4380" rtl="0" eaLnBrk="1" latinLnBrk="0" hangingPunct="1">
        <a:lnSpc>
          <a:spcPct val="90000"/>
        </a:lnSpc>
        <a:spcBef>
          <a:spcPct val="0"/>
        </a:spcBef>
        <a:buNone/>
        <a:defRPr sz="36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595" indent="-188595" algn="l" defTabSz="75438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1pPr>
      <a:lvl2pPr marL="56578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94297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3pPr>
      <a:lvl4pPr marL="132016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69735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207454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45173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82892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20611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1pPr>
      <a:lvl2pPr marL="37719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2pPr>
      <a:lvl3pPr marL="75438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3pPr>
      <a:lvl4pPr marL="113157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50876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26314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64033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01752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8140" y="145971"/>
            <a:ext cx="9528644" cy="10519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2800" dirty="0">
                <a:effectLst/>
                <a:uFill>
                  <a:solidFill>
                    <a:srgbClr val="000000"/>
                  </a:solidFill>
                </a:uFill>
                <a:latin typeface="Helvetica" pitchFamily="2" charset="0"/>
                <a:ea typeface="Calibri" panose="020F0502020204030204" pitchFamily="34" charset="0"/>
                <a:cs typeface="Calibri" panose="020F0502020204030204" pitchFamily="34" charset="0"/>
              </a:rPr>
              <a:t>CT Volumetric Analysis: Association of Renal Parenchyma and GFR Alteration in Nephrectomy Patients</a:t>
            </a:r>
            <a:endParaRPr lang="en-TH" sz="2800" dirty="0">
              <a:effectLst/>
              <a:uFill>
                <a:solidFill>
                  <a:srgbClr val="000000"/>
                </a:solidFill>
              </a:uFill>
              <a:latin typeface="Helvetica" pitchFamily="2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4001" y="5316800"/>
            <a:ext cx="2544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>
                <a:latin typeface="Helvetica" pitchFamily="2" charset="0"/>
              </a:rPr>
              <a:t>Saengthongpithak</a:t>
            </a:r>
            <a:r>
              <a:rPr lang="en-US" dirty="0">
                <a:latin typeface="Helvetica" pitchFamily="2" charset="0"/>
              </a:rPr>
              <a:t> et a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44001" y="3781043"/>
            <a:ext cx="918274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Helvetica" pitchFamily="2" charset="0"/>
              </a:rPr>
              <a:t>Computed topography of RCC patients or potential kidney donors were analyzed and identified into different volumes as figured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0609" y="4828542"/>
            <a:ext cx="3940150" cy="85759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8BD64B6-49BA-D997-D130-FF1CC39E41A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2316" y="1422288"/>
            <a:ext cx="2848610" cy="213677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DA3954E-0658-E63C-0A6C-67C72712734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001" y="1422288"/>
            <a:ext cx="3028315" cy="213677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5CAA63C-FA4B-E44B-0892-A9DEC4EAE7C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4584" y="1573726"/>
            <a:ext cx="3632200" cy="449580"/>
          </a:xfrm>
          <a:prstGeom prst="rect">
            <a:avLst/>
          </a:prstGeom>
          <a:solidFill>
            <a:srgbClr val="FFFFFF"/>
          </a:solidFill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6DCCBE6-FF53-0090-87DC-B0DF9B7D5EBB}"/>
              </a:ext>
            </a:extLst>
          </p:cNvPr>
          <p:cNvSpPr txBox="1"/>
          <p:nvPr/>
        </p:nvSpPr>
        <p:spPr>
          <a:xfrm>
            <a:off x="6255049" y="2304516"/>
            <a:ext cx="35593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Number of populations</a:t>
            </a:r>
          </a:p>
          <a:p>
            <a:r>
              <a:rPr lang="en-US" dirty="0">
                <a:latin typeface="Helvetica" pitchFamily="2" charset="0"/>
              </a:rPr>
              <a:t>PN 40 patients</a:t>
            </a:r>
          </a:p>
          <a:p>
            <a:r>
              <a:rPr lang="en-US" dirty="0">
                <a:latin typeface="Helvetica" pitchFamily="2" charset="0"/>
              </a:rPr>
              <a:t>RN 40 patients</a:t>
            </a:r>
          </a:p>
          <a:p>
            <a:r>
              <a:rPr lang="en-US" dirty="0">
                <a:latin typeface="Helvetica" pitchFamily="2" charset="0"/>
              </a:rPr>
              <a:t>DN 38 living donors</a:t>
            </a:r>
          </a:p>
        </p:txBody>
      </p:sp>
    </p:spTree>
    <p:extLst>
      <p:ext uri="{BB962C8B-B14F-4D97-AF65-F5344CB8AC3E}">
        <p14:creationId xmlns:p14="http://schemas.microsoft.com/office/powerpoint/2010/main" val="1986295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8140" y="145971"/>
            <a:ext cx="9528644" cy="10519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2800" dirty="0">
                <a:effectLst/>
                <a:uFill>
                  <a:solidFill>
                    <a:srgbClr val="000000"/>
                  </a:solidFill>
                </a:uFill>
                <a:latin typeface="Helvetica" pitchFamily="2" charset="0"/>
                <a:ea typeface="Calibri" panose="020F0502020204030204" pitchFamily="34" charset="0"/>
                <a:cs typeface="Calibri" panose="020F0502020204030204" pitchFamily="34" charset="0"/>
              </a:rPr>
              <a:t>CT Volumetric Analysis: Association of Renal Parenchyma and GFR Alteration in Nephrectomy Patients</a:t>
            </a:r>
            <a:endParaRPr lang="en-TH" sz="2800" dirty="0">
              <a:effectLst/>
              <a:uFill>
                <a:solidFill>
                  <a:srgbClr val="000000"/>
                </a:solidFill>
              </a:uFill>
              <a:latin typeface="Helvetica" pitchFamily="2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4001" y="5316800"/>
            <a:ext cx="2544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>
                <a:latin typeface="Helvetica" pitchFamily="2" charset="0"/>
              </a:rPr>
              <a:t>Saengthongpithak</a:t>
            </a:r>
            <a:r>
              <a:rPr lang="en-US" dirty="0">
                <a:latin typeface="Helvetica" pitchFamily="2" charset="0"/>
              </a:rPr>
              <a:t> et a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281336" y="1577538"/>
            <a:ext cx="355935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Helvetica" pitchFamily="2" charset="0"/>
              </a:rPr>
              <a:t>Volumetric based GFR </a:t>
            </a:r>
          </a:p>
          <a:p>
            <a:r>
              <a:rPr lang="en-US" sz="2400" dirty="0">
                <a:latin typeface="Helvetica" pitchFamily="2" charset="0"/>
              </a:rPr>
              <a:t>(VA–GFR) were calculated as figured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0936" y="4888005"/>
            <a:ext cx="3940150" cy="85759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621CFEE-CBCC-15E8-21B8-9B752E69932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14" y="3223513"/>
            <a:ext cx="5943600" cy="955675"/>
          </a:xfrm>
          <a:prstGeom prst="rect">
            <a:avLst/>
          </a:prstGeom>
          <a:solidFill>
            <a:schemeClr val="tx1"/>
          </a:solidFill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DA2B5F4-89F7-0AC4-D52A-14E8012EDB8F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714" y="1511553"/>
            <a:ext cx="5943600" cy="1473200"/>
          </a:xfrm>
          <a:prstGeom prst="rect">
            <a:avLst/>
          </a:prstGeom>
          <a:solidFill>
            <a:schemeClr val="tx1"/>
          </a:solidFill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5881505-BAE3-2E95-1A18-977CE6690AA8}"/>
              </a:ext>
            </a:extLst>
          </p:cNvPr>
          <p:cNvSpPr txBox="1"/>
          <p:nvPr/>
        </p:nvSpPr>
        <p:spPr>
          <a:xfrm>
            <a:off x="190641" y="4286328"/>
            <a:ext cx="5900296" cy="338554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Helvetica" pitchFamily="2" charset="0"/>
              </a:rPr>
              <a:t>Strong to Very strong correlation to NB-GFR were identified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99C688C-C026-229F-476C-D5E5D5C82F22}"/>
              </a:ext>
            </a:extLst>
          </p:cNvPr>
          <p:cNvSpPr txBox="1"/>
          <p:nvPr/>
        </p:nvSpPr>
        <p:spPr>
          <a:xfrm>
            <a:off x="6281336" y="2964924"/>
            <a:ext cx="3559350" cy="1477328"/>
          </a:xfrm>
          <a:prstGeom prst="rect">
            <a:avLst/>
          </a:prstGeom>
          <a:solidFill>
            <a:schemeClr val="accent2"/>
          </a:solidFill>
        </p:spPr>
        <p:txBody>
          <a:bodyPr wrap="squar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Pearson correlation coefficient (R)</a:t>
            </a:r>
          </a:p>
          <a:p>
            <a:r>
              <a:rPr lang="en-US" dirty="0">
                <a:latin typeface="Helvetica" pitchFamily="2" charset="0"/>
              </a:rPr>
              <a:t>PN : 0.81</a:t>
            </a:r>
          </a:p>
          <a:p>
            <a:r>
              <a:rPr lang="en-US" dirty="0">
                <a:latin typeface="Helvetica" pitchFamily="2" charset="0"/>
              </a:rPr>
              <a:t>RN : 0.63</a:t>
            </a:r>
          </a:p>
          <a:p>
            <a:r>
              <a:rPr lang="en-US" dirty="0">
                <a:latin typeface="Helvetica" pitchFamily="2" charset="0"/>
              </a:rPr>
              <a:t>DN : 0.76</a:t>
            </a:r>
          </a:p>
        </p:txBody>
      </p:sp>
    </p:spTree>
    <p:extLst>
      <p:ext uri="{BB962C8B-B14F-4D97-AF65-F5344CB8AC3E}">
        <p14:creationId xmlns:p14="http://schemas.microsoft.com/office/powerpoint/2010/main" val="35220720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8140" y="145971"/>
            <a:ext cx="9528644" cy="10519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2800" dirty="0">
                <a:effectLst/>
                <a:uFill>
                  <a:solidFill>
                    <a:srgbClr val="000000"/>
                  </a:solidFill>
                </a:uFill>
                <a:latin typeface="Helvetica" pitchFamily="2" charset="0"/>
                <a:ea typeface="Calibri" panose="020F0502020204030204" pitchFamily="34" charset="0"/>
                <a:cs typeface="Calibri" panose="020F0502020204030204" pitchFamily="34" charset="0"/>
              </a:rPr>
              <a:t>CT Volumetric Analysis: Association of Renal Parenchyma and GFR Alteration in Nephrectomy Patients</a:t>
            </a:r>
            <a:endParaRPr lang="en-TH" sz="2800" dirty="0">
              <a:effectLst/>
              <a:uFill>
                <a:solidFill>
                  <a:srgbClr val="000000"/>
                </a:solidFill>
              </a:uFill>
              <a:latin typeface="Helvetica" pitchFamily="2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4001" y="5316800"/>
            <a:ext cx="25442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>
                <a:latin typeface="Helvetica" pitchFamily="2" charset="0"/>
              </a:rPr>
              <a:t>Saengthongpithak</a:t>
            </a:r>
            <a:r>
              <a:rPr lang="en-US" dirty="0">
                <a:latin typeface="Helvetica" pitchFamily="2" charset="0"/>
              </a:rPr>
              <a:t> et a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791479" y="2175574"/>
            <a:ext cx="409530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Helvetica" pitchFamily="2" charset="0"/>
              </a:rPr>
              <a:t>Independent factors affecting NB-GFR</a:t>
            </a:r>
          </a:p>
          <a:p>
            <a:pPr marL="342900" indent="-342900">
              <a:buFontTx/>
              <a:buChar char="-"/>
            </a:pPr>
            <a:r>
              <a:rPr lang="en-US" dirty="0">
                <a:latin typeface="Helvetica" pitchFamily="2" charset="0"/>
              </a:rPr>
              <a:t>Advancing age</a:t>
            </a:r>
          </a:p>
          <a:p>
            <a:pPr marL="342900" indent="-342900">
              <a:buFontTx/>
              <a:buChar char="-"/>
            </a:pPr>
            <a:r>
              <a:rPr lang="en-US" dirty="0">
                <a:latin typeface="Helvetica" pitchFamily="2" charset="0"/>
              </a:rPr>
              <a:t>Male gender</a:t>
            </a:r>
          </a:p>
          <a:p>
            <a:pPr marL="342900" indent="-342900">
              <a:buFontTx/>
              <a:buChar char="-"/>
            </a:pPr>
            <a:r>
              <a:rPr lang="en-US" dirty="0">
                <a:latin typeface="Helvetica" pitchFamily="2" charset="0"/>
              </a:rPr>
              <a:t>VA-GFR</a:t>
            </a:r>
          </a:p>
          <a:p>
            <a:pPr marL="342900" indent="-342900">
              <a:buFontTx/>
              <a:buChar char="-"/>
            </a:pPr>
            <a:r>
              <a:rPr lang="en-US" dirty="0">
                <a:latin typeface="Helvetica" pitchFamily="2" charset="0"/>
              </a:rPr>
              <a:t>Hypertension</a:t>
            </a:r>
          </a:p>
          <a:p>
            <a:pPr marL="342900" indent="-342900">
              <a:buFontTx/>
              <a:buChar char="-"/>
            </a:pPr>
            <a:r>
              <a:rPr lang="en-US" dirty="0">
                <a:latin typeface="Helvetica" pitchFamily="2" charset="0"/>
              </a:rPr>
              <a:t>Preoperative proteinuria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0936" y="4888005"/>
            <a:ext cx="3940150" cy="857590"/>
          </a:xfrm>
          <a:prstGeom prst="rect">
            <a:avLst/>
          </a:prstGeom>
        </p:spPr>
      </p:pic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540A565-9BD0-4C4A-2085-B084CFA0CE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4670104"/>
              </p:ext>
            </p:extLst>
          </p:nvPr>
        </p:nvGraphicFramePr>
        <p:xfrm>
          <a:off x="244001" y="1305172"/>
          <a:ext cx="5389544" cy="39250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36663">
                  <a:extLst>
                    <a:ext uri="{9D8B030D-6E8A-4147-A177-3AD203B41FA5}">
                      <a16:colId xmlns:a16="http://schemas.microsoft.com/office/drawing/2014/main" val="2401833196"/>
                    </a:ext>
                  </a:extLst>
                </a:gridCol>
                <a:gridCol w="1615850">
                  <a:extLst>
                    <a:ext uri="{9D8B030D-6E8A-4147-A177-3AD203B41FA5}">
                      <a16:colId xmlns:a16="http://schemas.microsoft.com/office/drawing/2014/main" val="1021783080"/>
                    </a:ext>
                  </a:extLst>
                </a:gridCol>
                <a:gridCol w="1615217">
                  <a:extLst>
                    <a:ext uri="{9D8B030D-6E8A-4147-A177-3AD203B41FA5}">
                      <a16:colId xmlns:a16="http://schemas.microsoft.com/office/drawing/2014/main" val="2874970440"/>
                    </a:ext>
                  </a:extLst>
                </a:gridCol>
                <a:gridCol w="721814">
                  <a:extLst>
                    <a:ext uri="{9D8B030D-6E8A-4147-A177-3AD203B41FA5}">
                      <a16:colId xmlns:a16="http://schemas.microsoft.com/office/drawing/2014/main" val="1360951737"/>
                    </a:ext>
                  </a:extLst>
                </a:gridCol>
              </a:tblGrid>
              <a:tr h="321432">
                <a:tc gridSpan="2">
                  <a:txBody>
                    <a:bodyPr/>
                    <a:lstStyle/>
                    <a:p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 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 hMerge="1">
                  <a:txBody>
                    <a:bodyPr/>
                    <a:lstStyle/>
                    <a:p>
                      <a:endParaRPr lang="en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Multivariate analysis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 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extLst>
                  <a:ext uri="{0D108BD9-81ED-4DB2-BD59-A6C34878D82A}">
                    <a16:rowId xmlns:a16="http://schemas.microsoft.com/office/drawing/2014/main" val="3015516986"/>
                  </a:ext>
                </a:extLst>
              </a:tr>
              <a:tr h="321432">
                <a:tc gridSpan="2">
                  <a:txBody>
                    <a:bodyPr/>
                    <a:lstStyle/>
                    <a:p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 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 hMerge="1">
                  <a:txBody>
                    <a:bodyPr/>
                    <a:lstStyle/>
                    <a:p>
                      <a:endParaRPr lang="en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Coefficient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P Value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extLst>
                  <a:ext uri="{0D108BD9-81ED-4DB2-BD59-A6C34878D82A}">
                    <a16:rowId xmlns:a16="http://schemas.microsoft.com/office/drawing/2014/main" val="226474516"/>
                  </a:ext>
                </a:extLst>
              </a:tr>
              <a:tr h="326024">
                <a:tc gridSpan="2">
                  <a:txBody>
                    <a:bodyPr/>
                    <a:lstStyle/>
                    <a:p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Age*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-0.247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0.019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99604522"/>
                  </a:ext>
                </a:extLst>
              </a:tr>
              <a:tr h="322580">
                <a:tc gridSpan="2">
                  <a:txBody>
                    <a:bodyPr/>
                    <a:lstStyle/>
                    <a:p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Preoperative GFR*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 hMerge="1">
                  <a:txBody>
                    <a:bodyPr/>
                    <a:lstStyle/>
                    <a:p>
                      <a:endParaRPr lang="en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-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-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extLst>
                  <a:ext uri="{0D108BD9-81ED-4DB2-BD59-A6C34878D82A}">
                    <a16:rowId xmlns:a16="http://schemas.microsoft.com/office/drawing/2014/main" val="233254146"/>
                  </a:ext>
                </a:extLst>
              </a:tr>
              <a:tr h="310526">
                <a:tc gridSpan="2">
                  <a:txBody>
                    <a:bodyPr/>
                    <a:lstStyle/>
                    <a:p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VA-GFR*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0.777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&lt;0.001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4787949"/>
                  </a:ext>
                </a:extLst>
              </a:tr>
              <a:tr h="322580">
                <a:tc gridSpan="2">
                  <a:txBody>
                    <a:bodyPr/>
                    <a:lstStyle/>
                    <a:p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Male Gender</a:t>
                      </a:r>
                      <a:r>
                        <a:rPr lang="en-TH" sz="1200" kern="100" baseline="30000">
                          <a:effectLst/>
                          <a:latin typeface="Helvetica" pitchFamily="2" charset="0"/>
                        </a:rPr>
                        <a:t>#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-7.849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&lt;0.001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3758208"/>
                  </a:ext>
                </a:extLst>
              </a:tr>
              <a:tr h="327172">
                <a:tc gridSpan="2">
                  <a:txBody>
                    <a:bodyPr/>
                    <a:lstStyle/>
                    <a:p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Hypertension</a:t>
                      </a:r>
                      <a:r>
                        <a:rPr lang="en-TH" sz="1200" kern="100" baseline="30000">
                          <a:effectLst/>
                          <a:latin typeface="Helvetica" pitchFamily="2" charset="0"/>
                        </a:rPr>
                        <a:t>#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-5.807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0.05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7961025"/>
                  </a:ext>
                </a:extLst>
              </a:tr>
              <a:tr h="315692">
                <a:tc gridSpan="2">
                  <a:txBody>
                    <a:bodyPr/>
                    <a:lstStyle/>
                    <a:p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Diabetes Mellitus</a:t>
                      </a:r>
                      <a:r>
                        <a:rPr lang="en-TH" sz="1200" kern="100" baseline="30000">
                          <a:effectLst/>
                          <a:latin typeface="Helvetica" pitchFamily="2" charset="0"/>
                        </a:rPr>
                        <a:t>#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 hMerge="1">
                  <a:txBody>
                    <a:bodyPr/>
                    <a:lstStyle/>
                    <a:p>
                      <a:endParaRPr lang="en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-1.192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0.66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extLst>
                  <a:ext uri="{0D108BD9-81ED-4DB2-BD59-A6C34878D82A}">
                    <a16:rowId xmlns:a16="http://schemas.microsoft.com/office/drawing/2014/main" val="860593868"/>
                  </a:ext>
                </a:extLst>
              </a:tr>
              <a:tr h="320858">
                <a:tc gridSpan="2">
                  <a:txBody>
                    <a:bodyPr/>
                    <a:lstStyle/>
                    <a:p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Tumor size &gt; 7 cm</a:t>
                      </a:r>
                      <a:r>
                        <a:rPr lang="en-TH" sz="1200" kern="100" baseline="30000">
                          <a:effectLst/>
                          <a:latin typeface="Helvetica" pitchFamily="2" charset="0"/>
                        </a:rPr>
                        <a:t>#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 hMerge="1">
                  <a:txBody>
                    <a:bodyPr/>
                    <a:lstStyle/>
                    <a:p>
                      <a:endParaRPr lang="en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-2.746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0.417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extLst>
                  <a:ext uri="{0D108BD9-81ED-4DB2-BD59-A6C34878D82A}">
                    <a16:rowId xmlns:a16="http://schemas.microsoft.com/office/drawing/2014/main" val="3294381382"/>
                  </a:ext>
                </a:extLst>
              </a:tr>
              <a:tr h="400194">
                <a:tc rowSpan="2">
                  <a:txBody>
                    <a:bodyPr/>
                    <a:lstStyle/>
                    <a:p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Nephrectomy type</a:t>
                      </a:r>
                      <a:r>
                        <a:rPr lang="en-TH" sz="1200" kern="100" baseline="30000">
                          <a:effectLst/>
                          <a:latin typeface="Helvetica" pitchFamily="2" charset="0"/>
                        </a:rPr>
                        <a:t>#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>
                  <a:txBody>
                    <a:bodyPr/>
                    <a:lstStyle/>
                    <a:p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PN vs DN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-0.263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0.956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extLst>
                  <a:ext uri="{0D108BD9-81ED-4DB2-BD59-A6C34878D82A}">
                    <a16:rowId xmlns:a16="http://schemas.microsoft.com/office/drawing/2014/main" val="1433220203"/>
                  </a:ext>
                </a:extLst>
              </a:tr>
              <a:tr h="335207">
                <a:tc vMerge="1">
                  <a:txBody>
                    <a:bodyPr/>
                    <a:lstStyle/>
                    <a:p>
                      <a:endParaRPr lang="en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PN vs RN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4.771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0.262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/>
                </a:tc>
                <a:extLst>
                  <a:ext uri="{0D108BD9-81ED-4DB2-BD59-A6C34878D82A}">
                    <a16:rowId xmlns:a16="http://schemas.microsoft.com/office/drawing/2014/main" val="1916929285"/>
                  </a:ext>
                </a:extLst>
              </a:tr>
              <a:tr h="301343">
                <a:tc gridSpan="2">
                  <a:txBody>
                    <a:bodyPr/>
                    <a:lstStyle/>
                    <a:p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Preoperative Proteinuria</a:t>
                      </a:r>
                      <a:r>
                        <a:rPr lang="en-TH" sz="1200" kern="100" baseline="30000">
                          <a:effectLst/>
                          <a:latin typeface="Helvetica" pitchFamily="2" charset="0"/>
                        </a:rPr>
                        <a:t>#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T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-6.612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0.040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1548" marR="61548" marT="0" marB="0" anchor="ctr">
                    <a:solidFill>
                      <a:schemeClr val="accent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64776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843524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8140" y="145971"/>
            <a:ext cx="9528644" cy="10519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2800" dirty="0">
                <a:effectLst/>
                <a:uFill>
                  <a:solidFill>
                    <a:srgbClr val="000000"/>
                  </a:solidFill>
                </a:u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T Volumetric Analysis: Association of Renal Parenchyma and GFR Alteration in Nephrectomy Patients</a:t>
            </a:r>
            <a:endParaRPr lang="en-TH" sz="2800" dirty="0">
              <a:effectLst/>
              <a:uFill>
                <a:solidFill>
                  <a:srgbClr val="000000"/>
                </a:solidFill>
              </a:u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4001" y="5316800"/>
            <a:ext cx="23440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aengthongpithak</a:t>
            </a:r>
            <a:r>
              <a:rPr lang="en-US" dirty="0"/>
              <a:t> et a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877079" y="2286219"/>
            <a:ext cx="5009705" cy="584775"/>
          </a:xfrm>
          <a:prstGeom prst="rect">
            <a:avLst/>
          </a:prstGeom>
          <a:solidFill>
            <a:srgbClr val="FF0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3200" dirty="0"/>
              <a:t>Critical cutoff : GFR = 45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0936" y="4888005"/>
            <a:ext cx="3940150" cy="857590"/>
          </a:xfrm>
          <a:prstGeom prst="rect">
            <a:avLst/>
          </a:prstGeom>
        </p:spPr>
      </p:pic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47800F82-5C11-D0E9-B253-9887927B7BC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05152892"/>
              </p:ext>
            </p:extLst>
          </p:nvPr>
        </p:nvGraphicFramePr>
        <p:xfrm>
          <a:off x="358140" y="2036369"/>
          <a:ext cx="4377146" cy="31016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7FDE381F-2F20-7581-9401-A277269808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808" y="1334333"/>
            <a:ext cx="9886784" cy="584775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45720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TH" sz="1600" b="1" i="0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NB-GFR</a:t>
            </a:r>
            <a:r>
              <a:rPr kumimoji="0" lang="en-US" altLang="en-TH" sz="1600" b="0" i="0" strike="noStrike" cap="none" normalizeH="0" baseline="0" dirty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= 40.08 + 0.79(VA-GFR) - 7.734(if Male) - 6.632(if Hypertension) - 5.954(if Preoperative proteinuria) - 0.249(Age) + 6.726(if Radical nephrectomy) - 0.228(if Donor nephrectomy) </a:t>
            </a:r>
            <a:endParaRPr kumimoji="0" lang="en-US" altLang="en-TH" sz="3600" b="0" i="0" strike="noStrike" cap="none" normalizeH="0" baseline="0" dirty="0">
              <a:ln>
                <a:noFill/>
              </a:ln>
              <a:effectLst/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C29AACC-F72F-1CD3-4C0C-FF87BDFC969C}"/>
              </a:ext>
            </a:extLst>
          </p:cNvPr>
          <p:cNvSpPr txBox="1"/>
          <p:nvPr/>
        </p:nvSpPr>
        <p:spPr>
          <a:xfrm>
            <a:off x="4857584" y="3120845"/>
            <a:ext cx="502920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Performance on predicting unwilling events</a:t>
            </a:r>
          </a:p>
          <a:p>
            <a:r>
              <a:rPr lang="en-US" dirty="0"/>
              <a:t>Sensitivity 90.9%</a:t>
            </a:r>
          </a:p>
          <a:p>
            <a:r>
              <a:rPr lang="en-US" dirty="0"/>
              <a:t>Specificity 98.1 %</a:t>
            </a:r>
          </a:p>
          <a:p>
            <a:r>
              <a:rPr lang="en-US" dirty="0"/>
              <a:t>Accuracy 97.5%</a:t>
            </a:r>
          </a:p>
        </p:txBody>
      </p:sp>
    </p:spTree>
    <p:extLst>
      <p:ext uri="{BB962C8B-B14F-4D97-AF65-F5344CB8AC3E}">
        <p14:creationId xmlns:p14="http://schemas.microsoft.com/office/powerpoint/2010/main" val="30122479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8140" y="145971"/>
            <a:ext cx="9528644" cy="10519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2800" dirty="0">
                <a:effectLst/>
                <a:uFill>
                  <a:solidFill>
                    <a:srgbClr val="000000"/>
                  </a:solidFill>
                </a:u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T Volumetric Analysis: Association of Renal Parenchyma and GFR Alteration in Nephrectomy Patients</a:t>
            </a:r>
            <a:endParaRPr lang="en-TH" sz="2800" dirty="0">
              <a:effectLst/>
              <a:uFill>
                <a:solidFill>
                  <a:srgbClr val="000000"/>
                </a:solidFill>
              </a:u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44001" y="5316800"/>
            <a:ext cx="23440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aengthongpithak</a:t>
            </a:r>
            <a:r>
              <a:rPr lang="en-US" dirty="0"/>
              <a:t> et a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44001" y="3946344"/>
            <a:ext cx="920627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Helvetica" pitchFamily="2" charset="0"/>
              </a:rPr>
              <a:t>Comparing to former NB-GFR prediction model, our VA-GFR model provides </a:t>
            </a:r>
          </a:p>
          <a:p>
            <a:pPr algn="ctr"/>
            <a:r>
              <a:rPr lang="en-US" dirty="0">
                <a:latin typeface="Helvetica" pitchFamily="2" charset="0"/>
              </a:rPr>
              <a:t>a </a:t>
            </a:r>
            <a:r>
              <a:rPr lang="en-US" b="1" dirty="0">
                <a:latin typeface="Helvetica" pitchFamily="2" charset="0"/>
              </a:rPr>
              <a:t>higher accuracy on NB-GFR Prediction regardless of nephrectomy types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0936" y="4888005"/>
            <a:ext cx="3940150" cy="857590"/>
          </a:xfrm>
          <a:prstGeom prst="rect">
            <a:avLst/>
          </a:prstGeom>
        </p:spPr>
      </p:pic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6B89481-AAD0-301A-78A6-C4DC9E6801C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977815"/>
              </p:ext>
            </p:extLst>
          </p:nvPr>
        </p:nvGraphicFramePr>
        <p:xfrm>
          <a:off x="451945" y="1282262"/>
          <a:ext cx="8998329" cy="252175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428868">
                  <a:extLst>
                    <a:ext uri="{9D8B030D-6E8A-4147-A177-3AD203B41FA5}">
                      <a16:colId xmlns:a16="http://schemas.microsoft.com/office/drawing/2014/main" val="693588128"/>
                    </a:ext>
                  </a:extLst>
                </a:gridCol>
                <a:gridCol w="1890776">
                  <a:extLst>
                    <a:ext uri="{9D8B030D-6E8A-4147-A177-3AD203B41FA5}">
                      <a16:colId xmlns:a16="http://schemas.microsoft.com/office/drawing/2014/main" val="2632527786"/>
                    </a:ext>
                  </a:extLst>
                </a:gridCol>
                <a:gridCol w="1822198">
                  <a:extLst>
                    <a:ext uri="{9D8B030D-6E8A-4147-A177-3AD203B41FA5}">
                      <a16:colId xmlns:a16="http://schemas.microsoft.com/office/drawing/2014/main" val="341111076"/>
                    </a:ext>
                  </a:extLst>
                </a:gridCol>
                <a:gridCol w="1856487">
                  <a:extLst>
                    <a:ext uri="{9D8B030D-6E8A-4147-A177-3AD203B41FA5}">
                      <a16:colId xmlns:a16="http://schemas.microsoft.com/office/drawing/2014/main" val="1148472842"/>
                    </a:ext>
                  </a:extLst>
                </a:gridCol>
              </a:tblGrid>
              <a:tr h="325008">
                <a:tc>
                  <a:txBody>
                    <a:bodyPr/>
                    <a:lstStyle/>
                    <a:p>
                      <a:pPr algn="l"/>
                      <a:endParaRPr lang="en-TH" sz="1800" kern="100" dirty="0">
                        <a:effectLst/>
                        <a:latin typeface="Helvetica" pitchFamily="2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VA-GFR </a:t>
                      </a:r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m</a:t>
                      </a:r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odel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Helvetica" pitchFamily="2" charset="0"/>
                        </a:rPr>
                        <a:t>Palacios m</a:t>
                      </a:r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odel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Helvetica" pitchFamily="2" charset="0"/>
                        </a:rPr>
                        <a:t>Von Londen m</a:t>
                      </a:r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odel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10888162"/>
                  </a:ext>
                </a:extLst>
              </a:tr>
              <a:tr h="431034">
                <a:tc>
                  <a:txBody>
                    <a:bodyPr/>
                    <a:lstStyle/>
                    <a:p>
                      <a:pPr algn="thaiDist"/>
                      <a:r>
                        <a:rPr lang="en-TH" sz="1200" kern="100" dirty="0">
                          <a:effectLst/>
                          <a:latin typeface="Helvetica" pitchFamily="2" charset="0"/>
                        </a:rPr>
                        <a:t>Total events of predicted NB-GFR &lt; 45 (n)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12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Helvetica" pitchFamily="2" charset="0"/>
                        </a:rPr>
                        <a:t>13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6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724419209"/>
                  </a:ext>
                </a:extLst>
              </a:tr>
              <a:tr h="437271">
                <a:tc>
                  <a:txBody>
                    <a:bodyPr/>
                    <a:lstStyle/>
                    <a:p>
                      <a:pPr algn="thaiDist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Total false positive events </a:t>
                      </a:r>
                      <a:endParaRPr lang="en-TH" sz="1800" kern="100">
                        <a:effectLst/>
                        <a:latin typeface="Helvetica" pitchFamily="2" charset="0"/>
                      </a:endParaRPr>
                    </a:p>
                    <a:p>
                      <a:pPr algn="thaiDist"/>
                      <a:r>
                        <a:rPr lang="en-TH" sz="1200" kern="100">
                          <a:effectLst/>
                          <a:latin typeface="Helvetica" pitchFamily="2" charset="0"/>
                        </a:rPr>
                        <a:t>(Unexpected NB-GFR &gt; 45) (n)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2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3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Helvetica" pitchFamily="2" charset="0"/>
                        </a:rPr>
                        <a:t>4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55726851"/>
                  </a:ext>
                </a:extLst>
              </a:tr>
              <a:tr h="442815">
                <a:tc>
                  <a:txBody>
                    <a:bodyPr/>
                    <a:lstStyle/>
                    <a:p>
                      <a:pPr algn="thaiDist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Total false negative events </a:t>
                      </a:r>
                      <a:endParaRPr lang="en-TH" sz="1800" kern="100" dirty="0">
                        <a:effectLst/>
                        <a:latin typeface="Helvetica" pitchFamily="2" charset="0"/>
                      </a:endParaRPr>
                    </a:p>
                    <a:p>
                      <a:pPr algn="thaiDist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(Unexpected NB-GFR &lt; 45) (n)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1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2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Helvetica" pitchFamily="2" charset="0"/>
                        </a:rPr>
                        <a:t>10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881375556"/>
                  </a:ext>
                </a:extLst>
              </a:tr>
              <a:tr h="442815">
                <a:tc>
                  <a:txBody>
                    <a:bodyPr/>
                    <a:lstStyle/>
                    <a:p>
                      <a:pPr algn="thaiDist"/>
                      <a:r>
                        <a:rPr lang="en-US" sz="1200" kern="100">
                          <a:effectLst/>
                          <a:latin typeface="Helvetica" pitchFamily="2" charset="0"/>
                        </a:rPr>
                        <a:t>Sensitivity/ Specificity/ Accuracy (%)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90.9/ 98.1/ 97.5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72.7/ 95.3/ 93.2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9.1/ 95.3/ 87.2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30215910"/>
                  </a:ext>
                </a:extLst>
              </a:tr>
              <a:tr h="442815">
                <a:tc>
                  <a:txBody>
                    <a:bodyPr/>
                    <a:lstStyle/>
                    <a:p>
                      <a:pPr algn="thaiDist"/>
                      <a:r>
                        <a:rPr lang="en-US" sz="1200" kern="100">
                          <a:effectLst/>
                          <a:latin typeface="Helvetica" pitchFamily="2" charset="0"/>
                        </a:rPr>
                        <a:t>Cohen’s Kappa coefficient vs VA-GFR Model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-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>
                    <a:solidFill>
                      <a:schemeClr val="accent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Helvetica" pitchFamily="2" charset="0"/>
                        </a:rPr>
                        <a:t>0.776</a:t>
                      </a:r>
                      <a:endParaRPr lang="en-TH" sz="1800" kern="10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Helvetica" pitchFamily="2" charset="0"/>
                        </a:rPr>
                        <a:t>0.166</a:t>
                      </a:r>
                      <a:endParaRPr lang="en-TH" sz="1800" kern="100" dirty="0">
                        <a:effectLst/>
                        <a:latin typeface="Helvetica" pitchFamily="2" charset="0"/>
                        <a:ea typeface="Times New Roman" panose="02020603050405020304" pitchFamily="18" charset="0"/>
                        <a:cs typeface="Cordia New" panose="020B0304020202020204" pitchFamily="34" charset="-34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927293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52054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423</Words>
  <Application>Microsoft Macintosh PowerPoint</Application>
  <PresentationFormat>Custom</PresentationFormat>
  <Paragraphs>110</Paragraphs>
  <Slides>5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ID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ook,Olga R. (HMFP - Radiology)</dc:creator>
  <cp:lastModifiedBy>Gao s.</cp:lastModifiedBy>
  <cp:revision>18</cp:revision>
  <dcterms:created xsi:type="dcterms:W3CDTF">2020-06-22T01:49:04Z</dcterms:created>
  <dcterms:modified xsi:type="dcterms:W3CDTF">2024-10-31T08:57:11Z</dcterms:modified>
</cp:coreProperties>
</file>